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 descr="Une image contenant noir et blanc, monochrome&#10;&#10;Description générée automatiquement avec une confiance faible">
            <a:extLst>
              <a:ext uri="{FF2B5EF4-FFF2-40B4-BE49-F238E27FC236}">
                <a16:creationId xmlns:a16="http://schemas.microsoft.com/office/drawing/2014/main" id="{773827ED-D624-5BB2-9972-401722F7938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94540" y="845502"/>
            <a:ext cx="5731510" cy="516699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564105" y="417729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314072" y="417729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064039" y="417729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814005" y="417729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330A277F-9A12-B223-C056-4E7E7D96AB20}"/>
              </a:ext>
            </a:extLst>
          </p:cNvPr>
          <p:cNvSpPr txBox="1"/>
          <p:nvPr/>
        </p:nvSpPr>
        <p:spPr>
          <a:xfrm>
            <a:off x="6723170" y="2636999"/>
            <a:ext cx="4824000" cy="158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</a:t>
            </a:r>
            <a:r>
              <a:rPr lang="en-GB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displayed in Figure 2a. Wells A and B contain non-floated PC:NTA-Ni and PC:PE:NTA-Ni liposomes incubated with HR1-His peptides. Wells C and D contain the corresponding floated samples. 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47106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44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1</cp:revision>
  <dcterms:created xsi:type="dcterms:W3CDTF">2023-08-01T09:01:08Z</dcterms:created>
  <dcterms:modified xsi:type="dcterms:W3CDTF">2023-08-02T09:05:11Z</dcterms:modified>
</cp:coreProperties>
</file>